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81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393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249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777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395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369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857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545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959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936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929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465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AAD439-41CF-4244-9479-88D3CA9283D6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B0AD9D-2CA0-4CEE-A7C2-0FC7C1EAA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416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02074" y="3420199"/>
            <a:ext cx="8266057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Table 1.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hort characteristics for patients with IgAN or ADPKD who received a renal transplant. Values within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parentheses represent interquartile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ange; ESRD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– End-stage renal disease;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gAN – IgA Nephropathy; ADPKD – Autosomal dominant polycystic kidney disease. 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&lt;0.001 compared to pre transplant levels. *rs6677604 tags the </a:t>
            </a:r>
            <a:r>
              <a:rPr lang="en-GB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FHR3-1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deletion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5041267"/>
              </p:ext>
            </p:extLst>
          </p:nvPr>
        </p:nvGraphicFramePr>
        <p:xfrm>
          <a:off x="602073" y="1005595"/>
          <a:ext cx="7804336" cy="1907650"/>
        </p:xfrm>
        <a:graphic>
          <a:graphicData uri="http://schemas.openxmlformats.org/drawingml/2006/table">
            <a:tbl>
              <a:tblPr firstRow="1" firstCol="1" bandRow="1"/>
              <a:tblGrid>
                <a:gridCol w="3618235"/>
                <a:gridCol w="2235200"/>
                <a:gridCol w="1950901"/>
              </a:tblGrid>
              <a:tr h="42392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i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haracteristics</a:t>
                      </a:r>
                      <a:endParaRPr lang="en-GB" sz="600" b="1" i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dirty="0" err="1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gAN</a:t>
                      </a:r>
                      <a:r>
                        <a:rPr lang="en-GB" sz="600" b="1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n=28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DPKD (n=37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11961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le (percentage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 (75.0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6 (74.3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9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ucasian</a:t>
                      </a:r>
                      <a:r>
                        <a:rPr lang="en-GB" sz="6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percentage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4</a:t>
                      </a:r>
                      <a:r>
                        <a:rPr lang="en-GB" sz="6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68.6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 (53.6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9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dian age (range) – years</a:t>
                      </a: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6.9 (26.8-33.3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.7 (26.4-71.5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9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otyping</a:t>
                      </a:r>
                      <a:r>
                        <a:rPr lang="en-GB" sz="6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of rs6677604* GG / AG / AA – n (p</a:t>
                      </a: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rcentage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5 (89.3) / 3 (10.7) / 0 (0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 (62.2) / 11</a:t>
                      </a:r>
                      <a:r>
                        <a:rPr lang="en-GB" sz="6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.7) / 3 (8.1)</a:t>
                      </a:r>
                      <a:endParaRPr lang="en-GB" sz="600" baseline="30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9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dian time pre-transplant sample to transplant</a:t>
                      </a:r>
                      <a:r>
                        <a:rPr lang="en-GB" sz="6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– days 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(1-21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 (1-14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9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t transplant median </a:t>
                      </a:r>
                      <a:r>
                        <a:rPr lang="en-GB" sz="600" dirty="0" err="1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GFR</a:t>
                      </a: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– ml/min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5.7</a:t>
                      </a:r>
                      <a:r>
                        <a:rPr lang="en-GB" sz="6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34.7-84.4)</a:t>
                      </a:r>
                      <a:r>
                        <a:rPr lang="en-GB" sz="600" baseline="300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GB" sz="600" baseline="30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8.5</a:t>
                      </a:r>
                      <a:r>
                        <a:rPr lang="en-GB" sz="6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33.1-64.1)</a:t>
                      </a:r>
                      <a:r>
                        <a:rPr lang="en-GB" sz="600" baseline="300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GB" sz="600" baseline="30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9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dian time transplant</a:t>
                      </a:r>
                      <a:r>
                        <a:rPr lang="en-GB" sz="6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to post-transplant sample – days 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3 (84-112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3 (87-101)</a:t>
                      </a:r>
                      <a:endParaRPr lang="en-GB" sz="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093" marR="6309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95922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2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eed Elsevi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ed Elsevier</dc:creator>
  <cp:lastModifiedBy>Reed Elsevier</cp:lastModifiedBy>
  <cp:revision>1</cp:revision>
  <dcterms:created xsi:type="dcterms:W3CDTF">2017-04-25T15:06:13Z</dcterms:created>
  <dcterms:modified xsi:type="dcterms:W3CDTF">2017-04-25T15:06:25Z</dcterms:modified>
</cp:coreProperties>
</file>